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56" y="495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A5EF9D-E3A1-408B-B8B7-46721FBFBAC6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01F53F-7FA8-485D-9833-681497F91F0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01F53F-7FA8-485D-9833-681497F91F0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EC5A6-6C0D-421B-8F75-490032F5BEE5}" type="datetimeFigureOut">
              <a:rPr lang="en-US" smtClean="0"/>
              <a:pPr/>
              <a:t>4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5A4E8-7DDF-4BF7-B022-938E1081E52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1775178" y="304800"/>
            <a:ext cx="2187222" cy="2819400"/>
            <a:chOff x="2537178" y="964812"/>
            <a:chExt cx="2187222" cy="2819400"/>
          </a:xfrm>
        </p:grpSpPr>
        <p:pic>
          <p:nvPicPr>
            <p:cNvPr id="13" name="Picture 8"/>
            <p:cNvPicPr>
              <a:picLocks noChangeAspect="1" noChangeArrowheads="1"/>
            </p:cNvPicPr>
            <p:nvPr/>
          </p:nvPicPr>
          <p:blipFill>
            <a:blip r:embed="rId3" cstate="print"/>
            <a:srcRect l="586" r="3516"/>
            <a:stretch>
              <a:fillRect/>
            </a:stretch>
          </p:blipFill>
          <p:spPr bwMode="auto">
            <a:xfrm>
              <a:off x="3360571" y="1219200"/>
              <a:ext cx="1272009" cy="25650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4" name="TextBox 8"/>
            <p:cNvSpPr txBox="1">
              <a:spLocks noChangeArrowheads="1"/>
            </p:cNvSpPr>
            <p:nvPr/>
          </p:nvSpPr>
          <p:spPr bwMode="auto">
            <a:xfrm>
              <a:off x="3014004" y="964812"/>
              <a:ext cx="609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dirty="0"/>
                <a:t>A2</a:t>
              </a:r>
            </a:p>
          </p:txBody>
        </p:sp>
        <p:sp>
          <p:nvSpPr>
            <p:cNvPr id="15" name="TextBox 13"/>
            <p:cNvSpPr txBox="1">
              <a:spLocks noChangeArrowheads="1"/>
            </p:cNvSpPr>
            <p:nvPr/>
          </p:nvSpPr>
          <p:spPr bwMode="auto">
            <a:xfrm>
              <a:off x="3352800" y="964812"/>
              <a:ext cx="13716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600" dirty="0"/>
                <a:t>1 </a:t>
              </a:r>
              <a:r>
                <a:rPr lang="en-US" sz="1600" dirty="0" smtClean="0"/>
                <a:t>    2     3    4</a:t>
              </a:r>
              <a:endParaRPr lang="en-US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537178" y="2714891"/>
              <a:ext cx="838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500 </a:t>
              </a:r>
              <a:r>
                <a:rPr lang="en-US" sz="1400" dirty="0" err="1" smtClean="0"/>
                <a:t>bp</a:t>
              </a:r>
              <a:endParaRPr lang="en-US" sz="14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582334" y="2534355"/>
              <a:ext cx="838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700 </a:t>
              </a:r>
              <a:r>
                <a:rPr lang="en-US" sz="1400" dirty="0" err="1" smtClean="0"/>
                <a:t>bp</a:t>
              </a:r>
              <a:endParaRPr lang="en-US" sz="1400" dirty="0"/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>
              <a:off x="3135920" y="2884440"/>
              <a:ext cx="22860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>
              <a:off x="3161708" y="2701987"/>
              <a:ext cx="22860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19"/>
          <p:cNvGrpSpPr/>
          <p:nvPr/>
        </p:nvGrpSpPr>
        <p:grpSpPr>
          <a:xfrm>
            <a:off x="0" y="304800"/>
            <a:ext cx="2133600" cy="2899924"/>
            <a:chOff x="571500" y="962464"/>
            <a:chExt cx="2133600" cy="2899924"/>
          </a:xfrm>
        </p:grpSpPr>
        <p:sp>
          <p:nvSpPr>
            <p:cNvPr id="21" name="TextBox 10"/>
            <p:cNvSpPr txBox="1">
              <a:spLocks noChangeArrowheads="1"/>
            </p:cNvSpPr>
            <p:nvPr/>
          </p:nvSpPr>
          <p:spPr bwMode="auto">
            <a:xfrm>
              <a:off x="964812" y="962464"/>
              <a:ext cx="5334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dirty="0"/>
                <a:t>A1</a:t>
              </a:r>
            </a:p>
          </p:txBody>
        </p:sp>
        <p:grpSp>
          <p:nvGrpSpPr>
            <p:cNvPr id="22" name="Group 30"/>
            <p:cNvGrpSpPr/>
            <p:nvPr/>
          </p:nvGrpSpPr>
          <p:grpSpPr>
            <a:xfrm>
              <a:off x="571500" y="962464"/>
              <a:ext cx="2133600" cy="2899924"/>
              <a:chOff x="571500" y="962464"/>
              <a:chExt cx="2133600" cy="2899924"/>
            </a:xfrm>
          </p:grpSpPr>
          <p:sp>
            <p:nvSpPr>
              <p:cNvPr id="23" name="TextBox 22"/>
              <p:cNvSpPr txBox="1"/>
              <p:nvPr/>
            </p:nvSpPr>
            <p:spPr>
              <a:xfrm>
                <a:off x="571500" y="2511623"/>
                <a:ext cx="10668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250 </a:t>
                </a:r>
                <a:r>
                  <a:rPr lang="en-US" sz="1400" dirty="0" err="1" smtClean="0"/>
                  <a:t>bp</a:t>
                </a:r>
                <a:endParaRPr lang="en-US" sz="14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90550" y="2252004"/>
                <a:ext cx="838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750 </a:t>
                </a:r>
                <a:r>
                  <a:rPr lang="en-US" sz="1400" dirty="0" err="1" smtClean="0"/>
                  <a:t>bp</a:t>
                </a:r>
                <a:endParaRPr lang="en-US" sz="1400" dirty="0"/>
              </a:p>
            </p:txBody>
          </p:sp>
          <p:pic>
            <p:nvPicPr>
              <p:cNvPr id="25" name="Picture 5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257300" y="1219200"/>
                <a:ext cx="1155700" cy="26431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6" name="TextBox 9"/>
              <p:cNvSpPr txBox="1">
                <a:spLocks noChangeArrowheads="1"/>
              </p:cNvSpPr>
              <p:nvPr/>
            </p:nvSpPr>
            <p:spPr bwMode="auto">
              <a:xfrm>
                <a:off x="1257300" y="962464"/>
                <a:ext cx="14478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600" dirty="0"/>
                  <a:t>1 </a:t>
                </a:r>
                <a:r>
                  <a:rPr lang="en-US" sz="1600" dirty="0" smtClean="0"/>
                  <a:t>    2    3   4 </a:t>
                </a:r>
                <a:endParaRPr lang="en-US" sz="1600" dirty="0"/>
              </a:p>
            </p:txBody>
          </p:sp>
          <p:cxnSp>
            <p:nvCxnSpPr>
              <p:cNvPr id="27" name="Straight Arrow Connector 26"/>
              <p:cNvCxnSpPr/>
              <p:nvPr/>
            </p:nvCxnSpPr>
            <p:spPr>
              <a:xfrm>
                <a:off x="1109004" y="2410264"/>
                <a:ext cx="228600" cy="158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>
                <a:off x="1080868" y="2667000"/>
                <a:ext cx="228600" cy="158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6" name="Group 35"/>
          <p:cNvGrpSpPr/>
          <p:nvPr/>
        </p:nvGrpSpPr>
        <p:grpSpPr>
          <a:xfrm>
            <a:off x="1752600" y="3276600"/>
            <a:ext cx="2109788" cy="2947991"/>
            <a:chOff x="6781800" y="914397"/>
            <a:chExt cx="2109788" cy="2947991"/>
          </a:xfrm>
        </p:grpSpPr>
        <p:pic>
          <p:nvPicPr>
            <p:cNvPr id="37" name="Picture 7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7620000" y="1219200"/>
              <a:ext cx="1271588" cy="264318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38" name="TextBox 10"/>
            <p:cNvSpPr txBox="1">
              <a:spLocks noChangeArrowheads="1"/>
            </p:cNvSpPr>
            <p:nvPr/>
          </p:nvSpPr>
          <p:spPr bwMode="auto">
            <a:xfrm>
              <a:off x="7676445" y="914397"/>
              <a:ext cx="11430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600" dirty="0"/>
                <a:t>1 </a:t>
              </a:r>
              <a:r>
                <a:rPr lang="en-US" sz="1600" dirty="0" smtClean="0"/>
                <a:t>       2      </a:t>
              </a:r>
              <a:r>
                <a:rPr lang="en-US" sz="1600" dirty="0"/>
                <a:t>3 </a:t>
              </a:r>
            </a:p>
          </p:txBody>
        </p:sp>
        <p:sp>
          <p:nvSpPr>
            <p:cNvPr id="39" name="TextBox 11"/>
            <p:cNvSpPr txBox="1">
              <a:spLocks noChangeArrowheads="1"/>
            </p:cNvSpPr>
            <p:nvPr/>
          </p:nvSpPr>
          <p:spPr bwMode="auto">
            <a:xfrm>
              <a:off x="7239000" y="990600"/>
              <a:ext cx="609600" cy="381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dirty="0"/>
                <a:t>B2 </a:t>
              </a:r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>
              <a:off x="7467600" y="2057400"/>
              <a:ext cx="22860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>
              <a:off x="7391400" y="2286000"/>
              <a:ext cx="22860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6781800" y="2133600"/>
              <a:ext cx="838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 100 </a:t>
              </a:r>
              <a:r>
                <a:rPr lang="en-US" sz="1400" dirty="0" err="1" smtClean="0"/>
                <a:t>bp</a:t>
              </a:r>
              <a:endParaRPr lang="en-US" sz="14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819900" y="1905000"/>
              <a:ext cx="838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200 </a:t>
              </a:r>
              <a:r>
                <a:rPr lang="en-US" sz="1400" dirty="0" err="1" smtClean="0"/>
                <a:t>bp</a:t>
              </a:r>
              <a:endParaRPr lang="en-US" sz="1400" dirty="0"/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0" y="3200400"/>
            <a:ext cx="1981200" cy="2970698"/>
            <a:chOff x="5257800" y="1078086"/>
            <a:chExt cx="1981200" cy="2970698"/>
          </a:xfrm>
        </p:grpSpPr>
        <p:pic>
          <p:nvPicPr>
            <p:cNvPr id="47" name="Picture 9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960016" y="1405596"/>
              <a:ext cx="1130300" cy="264318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48" name="TextBox 11"/>
            <p:cNvSpPr txBox="1">
              <a:spLocks noChangeArrowheads="1"/>
            </p:cNvSpPr>
            <p:nvPr/>
          </p:nvSpPr>
          <p:spPr bwMode="auto">
            <a:xfrm>
              <a:off x="5643496" y="1143000"/>
              <a:ext cx="5334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dirty="0"/>
                <a:t>B1</a:t>
              </a:r>
            </a:p>
          </p:txBody>
        </p:sp>
        <p:sp>
          <p:nvSpPr>
            <p:cNvPr id="49" name="TextBox 14"/>
            <p:cNvSpPr txBox="1">
              <a:spLocks noChangeArrowheads="1"/>
            </p:cNvSpPr>
            <p:nvPr/>
          </p:nvSpPr>
          <p:spPr bwMode="auto">
            <a:xfrm>
              <a:off x="5867400" y="1078086"/>
              <a:ext cx="13716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dirty="0" smtClean="0"/>
                <a:t>   </a:t>
              </a:r>
              <a:r>
                <a:rPr lang="en-US" sz="1600" dirty="0" smtClean="0"/>
                <a:t>1      2     3   </a:t>
              </a:r>
              <a:endParaRPr lang="en-US" sz="16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257800" y="1987060"/>
              <a:ext cx="838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200 </a:t>
              </a:r>
              <a:r>
                <a:rPr lang="en-US" sz="1400" dirty="0" err="1" smtClean="0"/>
                <a:t>bp</a:t>
              </a:r>
              <a:endParaRPr lang="en-US" sz="14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257800" y="2145320"/>
              <a:ext cx="838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100 </a:t>
              </a:r>
              <a:r>
                <a:rPr lang="en-US" sz="1400" dirty="0" err="1" smtClean="0"/>
                <a:t>bp</a:t>
              </a:r>
              <a:endParaRPr lang="en-US" sz="1400" dirty="0"/>
            </a:p>
          </p:txBody>
        </p:sp>
        <p:cxnSp>
          <p:nvCxnSpPr>
            <p:cNvPr id="52" name="Straight Arrow Connector 51"/>
            <p:cNvCxnSpPr/>
            <p:nvPr/>
          </p:nvCxnSpPr>
          <p:spPr>
            <a:xfrm>
              <a:off x="5883816" y="2319996"/>
              <a:ext cx="22860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5867400" y="2209800"/>
              <a:ext cx="22860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Rectangle 34"/>
          <p:cNvSpPr/>
          <p:nvPr/>
        </p:nvSpPr>
        <p:spPr>
          <a:xfrm>
            <a:off x="0" y="6248400"/>
            <a:ext cx="6858000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 PCR-RFLP of the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pvdhps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gene.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: Representative images of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pvhps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before and after digestion with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Msp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1 enzyme.  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1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Undigested PCR products. Lane 1:  1 kb DNA Ladder, Lanes 2-4: Undigested PCR products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. A2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igestion profile of a fragment (703bp). Lane 1: 100bp DNA ladder, Lane 2 and 4: 703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ragment indicating wild type sequence. Lane 3: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s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1 cleaved fragment 655bp indicating mutations  at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383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s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1 digest 703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o 655bp and 48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f mutation is present at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383.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B: Representative images of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pvhps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before and after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Ms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1 digestion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B1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Undigested PCR products.  Lane 1: 100bp DNA ladder Lanes 2-4: Undigested PCR products (170bp)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. B2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igestion profile of a fragment (170bp). Lane 1: 100bp DNA ladder. Lane2: 170bp indicates 553G mutation. Lane3: 143bp indicates wild type sequence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s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1 digest 170 bp to 143bp an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28b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ragment if no mutation is present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0" y="0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Figure  </a:t>
            </a:r>
            <a:r>
              <a:rPr lang="en-US" b="1" dirty="0" err="1" smtClean="0"/>
              <a:t>S1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0" y="3810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0" y="3048000"/>
            <a:ext cx="4572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</TotalTime>
  <Words>229</Words>
  <Application>Microsoft Office PowerPoint</Application>
  <PresentationFormat>On-screen Show (4:3)</PresentationFormat>
  <Paragraphs>2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indows User</dc:creator>
  <cp:lastModifiedBy>0013357</cp:lastModifiedBy>
  <cp:revision>27</cp:revision>
  <dcterms:created xsi:type="dcterms:W3CDTF">2018-03-27T06:32:47Z</dcterms:created>
  <dcterms:modified xsi:type="dcterms:W3CDTF">2018-04-10T04:17:57Z</dcterms:modified>
</cp:coreProperties>
</file>